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110" d="100"/>
          <a:sy n="110" d="100"/>
        </p:scale>
        <p:origin x="-924" y="-54"/>
      </p:cViewPr>
      <p:guideLst>
        <p:guide orient="horz" pos="2577"/>
        <p:guide pos="431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A3D31-EDF8-40E2-BF2B-C809BF2102EA}" type="datetimeFigureOut">
              <a:rPr lang="en-US" smtClean="0"/>
              <a:t>6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BD699-6CD5-405D-8EC1-11E5FF665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63904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A3D31-EDF8-40E2-BF2B-C809BF2102EA}" type="datetimeFigureOut">
              <a:rPr lang="en-US" smtClean="0"/>
              <a:t>6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BD699-6CD5-405D-8EC1-11E5FF665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5029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A3D31-EDF8-40E2-BF2B-C809BF2102EA}" type="datetimeFigureOut">
              <a:rPr lang="en-US" smtClean="0"/>
              <a:t>6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BD699-6CD5-405D-8EC1-11E5FF665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87178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A3D31-EDF8-40E2-BF2B-C809BF2102EA}" type="datetimeFigureOut">
              <a:rPr lang="en-US" smtClean="0"/>
              <a:t>6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BD699-6CD5-405D-8EC1-11E5FF665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327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A3D31-EDF8-40E2-BF2B-C809BF2102EA}" type="datetimeFigureOut">
              <a:rPr lang="en-US" smtClean="0"/>
              <a:t>6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BD699-6CD5-405D-8EC1-11E5FF665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9833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A3D31-EDF8-40E2-BF2B-C809BF2102EA}" type="datetimeFigureOut">
              <a:rPr lang="en-US" smtClean="0"/>
              <a:t>6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BD699-6CD5-405D-8EC1-11E5FF665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3781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A3D31-EDF8-40E2-BF2B-C809BF2102EA}" type="datetimeFigureOut">
              <a:rPr lang="en-US" smtClean="0"/>
              <a:t>6/2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BD699-6CD5-405D-8EC1-11E5FF665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7716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A3D31-EDF8-40E2-BF2B-C809BF2102EA}" type="datetimeFigureOut">
              <a:rPr lang="en-US" smtClean="0"/>
              <a:t>6/2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BD699-6CD5-405D-8EC1-11E5FF665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75878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A3D31-EDF8-40E2-BF2B-C809BF2102EA}" type="datetimeFigureOut">
              <a:rPr lang="en-US" smtClean="0"/>
              <a:t>6/2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BD699-6CD5-405D-8EC1-11E5FF665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6315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A3D31-EDF8-40E2-BF2B-C809BF2102EA}" type="datetimeFigureOut">
              <a:rPr lang="en-US" smtClean="0"/>
              <a:t>6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BD699-6CD5-405D-8EC1-11E5FF665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4300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A3D31-EDF8-40E2-BF2B-C809BF2102EA}" type="datetimeFigureOut">
              <a:rPr lang="en-US" smtClean="0"/>
              <a:t>6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BD699-6CD5-405D-8EC1-11E5FF665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9091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DA3D31-EDF8-40E2-BF2B-C809BF2102EA}" type="datetimeFigureOut">
              <a:rPr lang="en-US" smtClean="0"/>
              <a:t>6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0BD699-6CD5-405D-8EC1-11E5FF665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4105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0"/>
            <a:ext cx="298036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tudy schematic for Arm C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Straight Arrow Connector 4"/>
          <p:cNvCxnSpPr/>
          <p:nvPr/>
        </p:nvCxnSpPr>
        <p:spPr>
          <a:xfrm>
            <a:off x="2357355" y="3717134"/>
            <a:ext cx="3879593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/>
          <p:cNvCxnSpPr/>
          <p:nvPr/>
        </p:nvCxnSpPr>
        <p:spPr>
          <a:xfrm>
            <a:off x="1568939" y="3717134"/>
            <a:ext cx="73152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>
            <a:off x="6465309" y="3717134"/>
            <a:ext cx="50292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2357355" y="3534254"/>
            <a:ext cx="0" cy="36576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2765440" y="3534254"/>
            <a:ext cx="0" cy="36576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3195194" y="3534254"/>
            <a:ext cx="0" cy="36576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3620614" y="3534254"/>
            <a:ext cx="0" cy="36576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4011365" y="3534254"/>
            <a:ext cx="0" cy="36576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4394905" y="3534254"/>
            <a:ext cx="0" cy="36576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4753863" y="3534254"/>
            <a:ext cx="0" cy="36576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5144614" y="3534254"/>
            <a:ext cx="0" cy="36576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5573645" y="3534254"/>
            <a:ext cx="0" cy="36576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7041677" y="3534254"/>
            <a:ext cx="0" cy="36576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6500693" y="3534254"/>
            <a:ext cx="0" cy="36576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6236948" y="3512135"/>
            <a:ext cx="186099" cy="40999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 flipH="1">
            <a:off x="6143898" y="3512135"/>
            <a:ext cx="186099" cy="40999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Left Brace 28"/>
          <p:cNvSpPr/>
          <p:nvPr/>
        </p:nvSpPr>
        <p:spPr>
          <a:xfrm rot="5400000">
            <a:off x="5948293" y="2954247"/>
            <a:ext cx="218850" cy="730655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Left Brace 29"/>
          <p:cNvSpPr/>
          <p:nvPr/>
        </p:nvSpPr>
        <p:spPr>
          <a:xfrm rot="16200000" flipV="1">
            <a:off x="3828162" y="2505053"/>
            <a:ext cx="270492" cy="3212107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Isosceles Triangle 30"/>
          <p:cNvSpPr/>
          <p:nvPr/>
        </p:nvSpPr>
        <p:spPr>
          <a:xfrm>
            <a:off x="5447687" y="3621174"/>
            <a:ext cx="91440" cy="18288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Isosceles Triangle 31"/>
          <p:cNvSpPr/>
          <p:nvPr/>
        </p:nvSpPr>
        <p:spPr>
          <a:xfrm>
            <a:off x="6454973" y="3621174"/>
            <a:ext cx="91440" cy="18288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Isosceles Triangle 32"/>
          <p:cNvSpPr/>
          <p:nvPr/>
        </p:nvSpPr>
        <p:spPr>
          <a:xfrm>
            <a:off x="1934699" y="3621174"/>
            <a:ext cx="91440" cy="18288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4" name="Straight Arrow Connector 33"/>
          <p:cNvCxnSpPr/>
          <p:nvPr/>
        </p:nvCxnSpPr>
        <p:spPr>
          <a:xfrm rot="5400000">
            <a:off x="1340339" y="3471452"/>
            <a:ext cx="45720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/>
          <p:cNvCxnSpPr/>
          <p:nvPr/>
        </p:nvCxnSpPr>
        <p:spPr>
          <a:xfrm rot="5400000">
            <a:off x="5687478" y="2820035"/>
            <a:ext cx="73152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/>
          <p:nvPr/>
        </p:nvCxnSpPr>
        <p:spPr>
          <a:xfrm rot="5400000">
            <a:off x="1989641" y="2815064"/>
            <a:ext cx="73152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/>
          <p:nvPr/>
        </p:nvCxnSpPr>
        <p:spPr>
          <a:xfrm rot="5400000">
            <a:off x="3645605" y="2820035"/>
            <a:ext cx="73152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1191427" y="2885084"/>
            <a:ext cx="7550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formed Consent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476757" y="1980714"/>
            <a:ext cx="1761196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epatux-m</a:t>
            </a:r>
          </a:p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osing D1 and D15 </a:t>
            </a:r>
          </a:p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f q28 Day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ycle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306608" y="2119213"/>
            <a:ext cx="1407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LT Assessment Period Ends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5156328" y="2119213"/>
            <a:ext cx="17611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ycles 3, 4, 5…</a:t>
            </a:r>
          </a:p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isits D1 and D15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085551" y="4225717"/>
            <a:ext cx="17611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i-weekly Visits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1004244" y="3806717"/>
            <a:ext cx="17611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reening</a:t>
            </a:r>
          </a:p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≤ 28 Days)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2137205" y="3209059"/>
            <a:ext cx="440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</a:p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1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975044" y="3209059"/>
            <a:ext cx="440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</a:p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15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538737" y="3209059"/>
            <a:ext cx="440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2</a:t>
            </a:r>
          </a:p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15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3791215" y="3209059"/>
            <a:ext cx="440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2</a:t>
            </a:r>
          </a:p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1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5353495" y="3209059"/>
            <a:ext cx="440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3</a:t>
            </a:r>
          </a:p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1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6095507" y="4322669"/>
            <a:ext cx="8113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nal Visit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6280472" y="4592196"/>
            <a:ext cx="1522409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5 Day Follow-up and Post-Treatment </a:t>
            </a:r>
          </a:p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rvival Assessment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Straight Arrow Connector 50"/>
          <p:cNvCxnSpPr/>
          <p:nvPr/>
        </p:nvCxnSpPr>
        <p:spPr>
          <a:xfrm rot="16200000" flipV="1">
            <a:off x="6722418" y="4303646"/>
            <a:ext cx="64008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/>
          <p:nvPr/>
        </p:nvCxnSpPr>
        <p:spPr>
          <a:xfrm rot="16200000" flipV="1">
            <a:off x="6317813" y="4166486"/>
            <a:ext cx="36576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Isosceles Triangle 52"/>
          <p:cNvSpPr/>
          <p:nvPr/>
        </p:nvSpPr>
        <p:spPr>
          <a:xfrm>
            <a:off x="1531091" y="5765448"/>
            <a:ext cx="91440" cy="18288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TextBox 53"/>
          <p:cNvSpPr txBox="1"/>
          <p:nvPr/>
        </p:nvSpPr>
        <p:spPr>
          <a:xfrm>
            <a:off x="1433312" y="5474133"/>
            <a:ext cx="6013185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, Cycle; D, Day</a:t>
            </a:r>
          </a:p>
          <a:p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Tumor Assessment Screening; every other cycle during treatment and Final Visit (if not within 3 weeks)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75698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" y="0"/>
            <a:ext cx="9144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erum concentration-time profiles of depatux-m in Arm C are presented as mean + standar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d deviation (SD) for the dose escalation cohort and mean – SD for the expanded cohort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2710" y="1294823"/>
            <a:ext cx="9146710" cy="42412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864715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63</TotalTime>
  <Words>126</Words>
  <Application>Microsoft Office PowerPoint</Application>
  <PresentationFormat>On-screen Show (4:3)</PresentationFormat>
  <Paragraphs>3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AbbVie In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h, Mrinal Y</dc:creator>
  <cp:lastModifiedBy>Shah, Mrinal Y</cp:lastModifiedBy>
  <cp:revision>20</cp:revision>
  <dcterms:created xsi:type="dcterms:W3CDTF">2016-12-01T20:41:53Z</dcterms:created>
  <dcterms:modified xsi:type="dcterms:W3CDTF">2017-06-28T21:53:45Z</dcterms:modified>
</cp:coreProperties>
</file>